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0479088" cy="13679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3" autoAdjust="0"/>
    <p:restoredTop sz="94660"/>
  </p:normalViewPr>
  <p:slideViewPr>
    <p:cSldViewPr snapToGrid="0">
      <p:cViewPr>
        <p:scale>
          <a:sx n="46" d="100"/>
          <a:sy n="46" d="100"/>
        </p:scale>
        <p:origin x="3408" y="8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5932" y="2238751"/>
            <a:ext cx="8907225" cy="4762488"/>
          </a:xfrm>
        </p:spPr>
        <p:txBody>
          <a:bodyPr anchor="b"/>
          <a:lstStyle>
            <a:lvl1pPr algn="ctr">
              <a:defRPr sz="687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9886" y="7184899"/>
            <a:ext cx="7859316" cy="3302709"/>
          </a:xfrm>
        </p:spPr>
        <p:txBody>
          <a:bodyPr/>
          <a:lstStyle>
            <a:lvl1pPr marL="0" indent="0" algn="ctr">
              <a:buNone/>
              <a:defRPr sz="2750"/>
            </a:lvl1pPr>
            <a:lvl2pPr marL="523951" indent="0" algn="ctr">
              <a:buNone/>
              <a:defRPr sz="2292"/>
            </a:lvl2pPr>
            <a:lvl3pPr marL="1047902" indent="0" algn="ctr">
              <a:buNone/>
              <a:defRPr sz="2063"/>
            </a:lvl3pPr>
            <a:lvl4pPr marL="1571854" indent="0" algn="ctr">
              <a:buNone/>
              <a:defRPr sz="1834"/>
            </a:lvl4pPr>
            <a:lvl5pPr marL="2095805" indent="0" algn="ctr">
              <a:buNone/>
              <a:defRPr sz="1834"/>
            </a:lvl5pPr>
            <a:lvl6pPr marL="2619756" indent="0" algn="ctr">
              <a:buNone/>
              <a:defRPr sz="1834"/>
            </a:lvl6pPr>
            <a:lvl7pPr marL="3143707" indent="0" algn="ctr">
              <a:buNone/>
              <a:defRPr sz="1834"/>
            </a:lvl7pPr>
            <a:lvl8pPr marL="3667658" indent="0" algn="ctr">
              <a:buNone/>
              <a:defRPr sz="1834"/>
            </a:lvl8pPr>
            <a:lvl9pPr marL="4191610" indent="0" algn="ctr">
              <a:buNone/>
              <a:defRPr sz="183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5930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9858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99098" y="728306"/>
            <a:ext cx="2259553" cy="1159273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20438" y="728306"/>
            <a:ext cx="6647671" cy="1159273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0127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644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4980" y="3410376"/>
            <a:ext cx="9038213" cy="5690286"/>
          </a:xfrm>
        </p:spPr>
        <p:txBody>
          <a:bodyPr anchor="b"/>
          <a:lstStyle>
            <a:lvl1pPr>
              <a:defRPr sz="687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4980" y="9154495"/>
            <a:ext cx="9038213" cy="2992387"/>
          </a:xfrm>
        </p:spPr>
        <p:txBody>
          <a:bodyPr/>
          <a:lstStyle>
            <a:lvl1pPr marL="0" indent="0">
              <a:buNone/>
              <a:defRPr sz="2750">
                <a:solidFill>
                  <a:schemeClr val="tx1"/>
                </a:solidFill>
              </a:defRPr>
            </a:lvl1pPr>
            <a:lvl2pPr marL="523951" indent="0">
              <a:buNone/>
              <a:defRPr sz="2292">
                <a:solidFill>
                  <a:schemeClr val="tx1">
                    <a:tint val="75000"/>
                  </a:schemeClr>
                </a:solidFill>
              </a:defRPr>
            </a:lvl2pPr>
            <a:lvl3pPr marL="1047902" indent="0">
              <a:buNone/>
              <a:defRPr sz="2063">
                <a:solidFill>
                  <a:schemeClr val="tx1">
                    <a:tint val="75000"/>
                  </a:schemeClr>
                </a:solidFill>
              </a:defRPr>
            </a:lvl3pPr>
            <a:lvl4pPr marL="1571854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4pPr>
            <a:lvl5pPr marL="2095805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5pPr>
            <a:lvl6pPr marL="2619756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6pPr>
            <a:lvl7pPr marL="3143707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7pPr>
            <a:lvl8pPr marL="3667658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8pPr>
            <a:lvl9pPr marL="4191610" indent="0">
              <a:buNone/>
              <a:defRPr sz="18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1158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20438" y="3641531"/>
            <a:ext cx="4453612" cy="867950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05039" y="3641531"/>
            <a:ext cx="4453612" cy="867950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9970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1802" y="728309"/>
            <a:ext cx="9038213" cy="264406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1803" y="3353376"/>
            <a:ext cx="4433145" cy="1643437"/>
          </a:xfrm>
        </p:spPr>
        <p:txBody>
          <a:bodyPr anchor="b"/>
          <a:lstStyle>
            <a:lvl1pPr marL="0" indent="0">
              <a:buNone/>
              <a:defRPr sz="2750" b="1"/>
            </a:lvl1pPr>
            <a:lvl2pPr marL="523951" indent="0">
              <a:buNone/>
              <a:defRPr sz="2292" b="1"/>
            </a:lvl2pPr>
            <a:lvl3pPr marL="1047902" indent="0">
              <a:buNone/>
              <a:defRPr sz="2063" b="1"/>
            </a:lvl3pPr>
            <a:lvl4pPr marL="1571854" indent="0">
              <a:buNone/>
              <a:defRPr sz="1834" b="1"/>
            </a:lvl4pPr>
            <a:lvl5pPr marL="2095805" indent="0">
              <a:buNone/>
              <a:defRPr sz="1834" b="1"/>
            </a:lvl5pPr>
            <a:lvl6pPr marL="2619756" indent="0">
              <a:buNone/>
              <a:defRPr sz="1834" b="1"/>
            </a:lvl6pPr>
            <a:lvl7pPr marL="3143707" indent="0">
              <a:buNone/>
              <a:defRPr sz="1834" b="1"/>
            </a:lvl7pPr>
            <a:lvl8pPr marL="3667658" indent="0">
              <a:buNone/>
              <a:defRPr sz="1834" b="1"/>
            </a:lvl8pPr>
            <a:lvl9pPr marL="4191610" indent="0">
              <a:buNone/>
              <a:defRPr sz="18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1803" y="4996813"/>
            <a:ext cx="4433145" cy="734955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305039" y="3353376"/>
            <a:ext cx="4454977" cy="1643437"/>
          </a:xfrm>
        </p:spPr>
        <p:txBody>
          <a:bodyPr anchor="b"/>
          <a:lstStyle>
            <a:lvl1pPr marL="0" indent="0">
              <a:buNone/>
              <a:defRPr sz="2750" b="1"/>
            </a:lvl1pPr>
            <a:lvl2pPr marL="523951" indent="0">
              <a:buNone/>
              <a:defRPr sz="2292" b="1"/>
            </a:lvl2pPr>
            <a:lvl3pPr marL="1047902" indent="0">
              <a:buNone/>
              <a:defRPr sz="2063" b="1"/>
            </a:lvl3pPr>
            <a:lvl4pPr marL="1571854" indent="0">
              <a:buNone/>
              <a:defRPr sz="1834" b="1"/>
            </a:lvl4pPr>
            <a:lvl5pPr marL="2095805" indent="0">
              <a:buNone/>
              <a:defRPr sz="1834" b="1"/>
            </a:lvl5pPr>
            <a:lvl6pPr marL="2619756" indent="0">
              <a:buNone/>
              <a:defRPr sz="1834" b="1"/>
            </a:lvl6pPr>
            <a:lvl7pPr marL="3143707" indent="0">
              <a:buNone/>
              <a:defRPr sz="1834" b="1"/>
            </a:lvl7pPr>
            <a:lvl8pPr marL="3667658" indent="0">
              <a:buNone/>
              <a:defRPr sz="1834" b="1"/>
            </a:lvl8pPr>
            <a:lvl9pPr marL="4191610" indent="0">
              <a:buNone/>
              <a:defRPr sz="183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305039" y="4996813"/>
            <a:ext cx="4454977" cy="734955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341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5454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4743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1802" y="911966"/>
            <a:ext cx="3379779" cy="3191881"/>
          </a:xfrm>
        </p:spPr>
        <p:txBody>
          <a:bodyPr anchor="b"/>
          <a:lstStyle>
            <a:lvl1pPr>
              <a:defRPr sz="3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54977" y="1969596"/>
            <a:ext cx="5305038" cy="9721303"/>
          </a:xfrm>
        </p:spPr>
        <p:txBody>
          <a:bodyPr/>
          <a:lstStyle>
            <a:lvl1pPr>
              <a:defRPr sz="3667"/>
            </a:lvl1pPr>
            <a:lvl2pPr>
              <a:defRPr sz="3209"/>
            </a:lvl2pPr>
            <a:lvl3pPr>
              <a:defRPr sz="2750"/>
            </a:lvl3pPr>
            <a:lvl4pPr>
              <a:defRPr sz="2292"/>
            </a:lvl4pPr>
            <a:lvl5pPr>
              <a:defRPr sz="2292"/>
            </a:lvl5pPr>
            <a:lvl6pPr>
              <a:defRPr sz="2292"/>
            </a:lvl6pPr>
            <a:lvl7pPr>
              <a:defRPr sz="2292"/>
            </a:lvl7pPr>
            <a:lvl8pPr>
              <a:defRPr sz="2292"/>
            </a:lvl8pPr>
            <a:lvl9pPr>
              <a:defRPr sz="2292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1802" y="4103846"/>
            <a:ext cx="3379779" cy="7602883"/>
          </a:xfrm>
        </p:spPr>
        <p:txBody>
          <a:bodyPr/>
          <a:lstStyle>
            <a:lvl1pPr marL="0" indent="0">
              <a:buNone/>
              <a:defRPr sz="1834"/>
            </a:lvl1pPr>
            <a:lvl2pPr marL="523951" indent="0">
              <a:buNone/>
              <a:defRPr sz="1604"/>
            </a:lvl2pPr>
            <a:lvl3pPr marL="1047902" indent="0">
              <a:buNone/>
              <a:defRPr sz="1375"/>
            </a:lvl3pPr>
            <a:lvl4pPr marL="1571854" indent="0">
              <a:buNone/>
              <a:defRPr sz="1146"/>
            </a:lvl4pPr>
            <a:lvl5pPr marL="2095805" indent="0">
              <a:buNone/>
              <a:defRPr sz="1146"/>
            </a:lvl5pPr>
            <a:lvl6pPr marL="2619756" indent="0">
              <a:buNone/>
              <a:defRPr sz="1146"/>
            </a:lvl6pPr>
            <a:lvl7pPr marL="3143707" indent="0">
              <a:buNone/>
              <a:defRPr sz="1146"/>
            </a:lvl7pPr>
            <a:lvl8pPr marL="3667658" indent="0">
              <a:buNone/>
              <a:defRPr sz="1146"/>
            </a:lvl8pPr>
            <a:lvl9pPr marL="4191610" indent="0">
              <a:buNone/>
              <a:defRPr sz="1146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3251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1802" y="911966"/>
            <a:ext cx="3379779" cy="3191881"/>
          </a:xfrm>
        </p:spPr>
        <p:txBody>
          <a:bodyPr anchor="b"/>
          <a:lstStyle>
            <a:lvl1pPr>
              <a:defRPr sz="3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54977" y="1969596"/>
            <a:ext cx="5305038" cy="9721303"/>
          </a:xfrm>
        </p:spPr>
        <p:txBody>
          <a:bodyPr anchor="t"/>
          <a:lstStyle>
            <a:lvl1pPr marL="0" indent="0">
              <a:buNone/>
              <a:defRPr sz="3667"/>
            </a:lvl1pPr>
            <a:lvl2pPr marL="523951" indent="0">
              <a:buNone/>
              <a:defRPr sz="3209"/>
            </a:lvl2pPr>
            <a:lvl3pPr marL="1047902" indent="0">
              <a:buNone/>
              <a:defRPr sz="2750"/>
            </a:lvl3pPr>
            <a:lvl4pPr marL="1571854" indent="0">
              <a:buNone/>
              <a:defRPr sz="2292"/>
            </a:lvl4pPr>
            <a:lvl5pPr marL="2095805" indent="0">
              <a:buNone/>
              <a:defRPr sz="2292"/>
            </a:lvl5pPr>
            <a:lvl6pPr marL="2619756" indent="0">
              <a:buNone/>
              <a:defRPr sz="2292"/>
            </a:lvl6pPr>
            <a:lvl7pPr marL="3143707" indent="0">
              <a:buNone/>
              <a:defRPr sz="2292"/>
            </a:lvl7pPr>
            <a:lvl8pPr marL="3667658" indent="0">
              <a:buNone/>
              <a:defRPr sz="2292"/>
            </a:lvl8pPr>
            <a:lvl9pPr marL="4191610" indent="0">
              <a:buNone/>
              <a:defRPr sz="2292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1802" y="4103846"/>
            <a:ext cx="3379779" cy="7602883"/>
          </a:xfrm>
        </p:spPr>
        <p:txBody>
          <a:bodyPr/>
          <a:lstStyle>
            <a:lvl1pPr marL="0" indent="0">
              <a:buNone/>
              <a:defRPr sz="1834"/>
            </a:lvl1pPr>
            <a:lvl2pPr marL="523951" indent="0">
              <a:buNone/>
              <a:defRPr sz="1604"/>
            </a:lvl2pPr>
            <a:lvl3pPr marL="1047902" indent="0">
              <a:buNone/>
              <a:defRPr sz="1375"/>
            </a:lvl3pPr>
            <a:lvl4pPr marL="1571854" indent="0">
              <a:buNone/>
              <a:defRPr sz="1146"/>
            </a:lvl4pPr>
            <a:lvl5pPr marL="2095805" indent="0">
              <a:buNone/>
              <a:defRPr sz="1146"/>
            </a:lvl5pPr>
            <a:lvl6pPr marL="2619756" indent="0">
              <a:buNone/>
              <a:defRPr sz="1146"/>
            </a:lvl6pPr>
            <a:lvl7pPr marL="3143707" indent="0">
              <a:buNone/>
              <a:defRPr sz="1146"/>
            </a:lvl7pPr>
            <a:lvl8pPr marL="3667658" indent="0">
              <a:buNone/>
              <a:defRPr sz="1146"/>
            </a:lvl8pPr>
            <a:lvl9pPr marL="4191610" indent="0">
              <a:buNone/>
              <a:defRPr sz="1146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39477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20438" y="728309"/>
            <a:ext cx="9038213" cy="2644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0438" y="3641531"/>
            <a:ext cx="9038213" cy="86795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20437" y="12678862"/>
            <a:ext cx="2357795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001130-E268-43D8-9DC9-158E53E63E91}" type="datetimeFigureOut">
              <a:rPr kumimoji="1" lang="ja-JP" altLang="en-US" smtClean="0"/>
              <a:t>2024/3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71198" y="12678862"/>
            <a:ext cx="3536692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400856" y="12678862"/>
            <a:ext cx="2357795" cy="7283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B2171C-EA10-4A4C-935B-EAA11B7D62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5553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47902" rtl="0" eaLnBrk="1" latinLnBrk="0" hangingPunct="1">
        <a:lnSpc>
          <a:spcPct val="90000"/>
        </a:lnSpc>
        <a:spcBef>
          <a:spcPct val="0"/>
        </a:spcBef>
        <a:buNone/>
        <a:defRPr kumimoji="1" sz="504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1976" indent="-261976" algn="l" defTabSz="1047902" rtl="0" eaLnBrk="1" latinLnBrk="0" hangingPunct="1">
        <a:lnSpc>
          <a:spcPct val="90000"/>
        </a:lnSpc>
        <a:spcBef>
          <a:spcPts val="1146"/>
        </a:spcBef>
        <a:buFont typeface="Arial" panose="020B0604020202020204" pitchFamily="34" charset="0"/>
        <a:buChar char="•"/>
        <a:defRPr kumimoji="1" sz="3209" kern="1200">
          <a:solidFill>
            <a:schemeClr val="tx1"/>
          </a:solidFill>
          <a:latin typeface="+mn-lt"/>
          <a:ea typeface="+mn-ea"/>
          <a:cs typeface="+mn-cs"/>
        </a:defRPr>
      </a:lvl1pPr>
      <a:lvl2pPr marL="785927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750" kern="1200">
          <a:solidFill>
            <a:schemeClr val="tx1"/>
          </a:solidFill>
          <a:latin typeface="+mn-lt"/>
          <a:ea typeface="+mn-ea"/>
          <a:cs typeface="+mn-cs"/>
        </a:defRPr>
      </a:lvl2pPr>
      <a:lvl3pPr marL="1309878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292" kern="1200">
          <a:solidFill>
            <a:schemeClr val="tx1"/>
          </a:solidFill>
          <a:latin typeface="+mn-lt"/>
          <a:ea typeface="+mn-ea"/>
          <a:cs typeface="+mn-cs"/>
        </a:defRPr>
      </a:lvl3pPr>
      <a:lvl4pPr marL="1833829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4pPr>
      <a:lvl5pPr marL="2357780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5pPr>
      <a:lvl6pPr marL="2881732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6pPr>
      <a:lvl7pPr marL="3405683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7pPr>
      <a:lvl8pPr marL="3929634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8pPr>
      <a:lvl9pPr marL="4453585" indent="-261976" algn="l" defTabSz="1047902" rtl="0" eaLnBrk="1" latinLnBrk="0" hangingPunct="1">
        <a:lnSpc>
          <a:spcPct val="90000"/>
        </a:lnSpc>
        <a:spcBef>
          <a:spcPts val="573"/>
        </a:spcBef>
        <a:buFont typeface="Arial" panose="020B0604020202020204" pitchFamily="34" charset="0"/>
        <a:buChar char="•"/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1pPr>
      <a:lvl2pPr marL="523951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2pPr>
      <a:lvl3pPr marL="1047902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3pPr>
      <a:lvl4pPr marL="1571854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4pPr>
      <a:lvl5pPr marL="2095805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5pPr>
      <a:lvl6pPr marL="2619756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6pPr>
      <a:lvl7pPr marL="3143707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7pPr>
      <a:lvl8pPr marL="3667658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8pPr>
      <a:lvl9pPr marL="4191610" algn="l" defTabSz="1047902" rtl="0" eaLnBrk="1" latinLnBrk="0" hangingPunct="1">
        <a:defRPr kumimoji="1" sz="2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D76C89F-F27F-B354-4673-EEE72A48AD16}"/>
              </a:ext>
            </a:extLst>
          </p:cNvPr>
          <p:cNvSpPr txBox="1"/>
          <p:nvPr/>
        </p:nvSpPr>
        <p:spPr>
          <a:xfrm>
            <a:off x="146328" y="13051703"/>
            <a:ext cx="10332760" cy="369332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Heatmap of top-106 significantly altered GO biological process terms among the four groups. The heatmap without term names was shown in Fig. 3D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D0E9F471-B75E-3AB8-A1D0-EC10BF83A95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67" y="129131"/>
            <a:ext cx="10446723" cy="127012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3565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</TotalTime>
  <Words>30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齋藤　琢</dc:creator>
  <cp:lastModifiedBy>真壁　健太</cp:lastModifiedBy>
  <cp:revision>5</cp:revision>
  <dcterms:created xsi:type="dcterms:W3CDTF">2023-12-18T01:25:32Z</dcterms:created>
  <dcterms:modified xsi:type="dcterms:W3CDTF">2024-03-16T03:47:59Z</dcterms:modified>
</cp:coreProperties>
</file>